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384" y="5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80A70-6568-4484-8A20-3FABB7756E12}" type="datetimeFigureOut">
              <a:rPr lang="en-US" smtClean="0"/>
              <a:pPr/>
              <a:t>4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BE8E8-4EFA-4621-BF7C-22519DA9A1D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l="21824" t="20579" r="5212" b="49178"/>
          <a:stretch>
            <a:fillRect/>
          </a:stretch>
        </p:blipFill>
        <p:spPr bwMode="auto">
          <a:xfrm>
            <a:off x="3769962" y="2743200"/>
            <a:ext cx="1271114" cy="6355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 l="12484" b="67330"/>
          <a:stretch>
            <a:fillRect/>
          </a:stretch>
        </p:blipFill>
        <p:spPr bwMode="auto">
          <a:xfrm>
            <a:off x="1694214" y="2743200"/>
            <a:ext cx="1340106" cy="6212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>
            <a:off x="1676400" y="3364468"/>
            <a:ext cx="3476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   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IP      No AB                     IP      No AB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600200" y="3886200"/>
            <a:ext cx="425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Western: anti-CTCF polyclonal antibody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627902" y="3582330"/>
            <a:ext cx="3877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(Mouse 10H)       (Rabbit polyclonal)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743200" y="1371600"/>
            <a:ext cx="1605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itchFamily="34" charset="0"/>
                <a:cs typeface="Arial" pitchFamily="34" charset="0"/>
              </a:rPr>
              <a:t>Anti-PAR  IP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1398983" y="2065852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CF10A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2033363" y="2069990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CF10A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3451025" y="2069662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CF10A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4022692" y="2075272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CF10A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717590" y="206985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M159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325391" y="206986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M159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4308195" y="206244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M159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3727575" y="206245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M159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1816924" y="3429000"/>
            <a:ext cx="5478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2514600" y="3429000"/>
            <a:ext cx="4572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4527120" y="3429000"/>
            <a:ext cx="4572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858150" y="3429000"/>
            <a:ext cx="533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3760166" y="2947074"/>
            <a:ext cx="76200" cy="0"/>
          </a:xfrm>
          <a:prstGeom prst="straightConnector1">
            <a:avLst/>
          </a:prstGeom>
          <a:ln w="25400" cap="sq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766378" y="3106102"/>
            <a:ext cx="76200" cy="0"/>
          </a:xfrm>
          <a:prstGeom prst="straightConnector1">
            <a:avLst/>
          </a:prstGeom>
          <a:ln w="25400" cap="sq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925290" y="2801586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CTCF-180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930234" y="2965862"/>
            <a:ext cx="901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CTCF-13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876304" y="1061856"/>
            <a:ext cx="3298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3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Similar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PARylation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of CTCF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9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The Ohio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uey-Jen Lin</dc:creator>
  <cp:lastModifiedBy>Huey-Jen Lin</cp:lastModifiedBy>
  <cp:revision>18</cp:revision>
  <dcterms:created xsi:type="dcterms:W3CDTF">2012-03-23T01:29:48Z</dcterms:created>
  <dcterms:modified xsi:type="dcterms:W3CDTF">2012-04-26T20:46:10Z</dcterms:modified>
</cp:coreProperties>
</file>